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P Zhang" initials="Z" lastIdx="1" clrIdx="0">
    <p:extLst>
      <p:ext uri="{19B8F6BF-5375-455C-9EA6-DF929625EA0E}">
        <p15:presenceInfo xmlns:p15="http://schemas.microsoft.com/office/powerpoint/2012/main" userId="MP Zha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>
        <p:scale>
          <a:sx n="100" d="100"/>
          <a:sy n="100" d="100"/>
        </p:scale>
        <p:origin x="678" y="-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5406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378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049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271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7422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229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834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029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451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9395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665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9C20CE-2B53-4351-93E1-41A125FF23AE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32EFE-7C71-4012-9D72-F988CF9189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834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BE30A04-FAF0-D0DC-E86F-E39E36954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2025" y="917995"/>
            <a:ext cx="5261304" cy="361524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F0FA4FC-4726-5EDB-5AE2-8C4D81461841}"/>
              </a:ext>
            </a:extLst>
          </p:cNvPr>
          <p:cNvSpPr txBox="1"/>
          <p:nvPr/>
        </p:nvSpPr>
        <p:spPr>
          <a:xfrm>
            <a:off x="1406063" y="4622257"/>
            <a:ext cx="63318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tic transformation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g1-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nto ginseng adventitious roots for RNAi gene expression repression. (A) Pre-culture of ginseng adventitious roots. (B) Co-culture of ginseng adventitious roots with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4 containing the PgRg1-3-pART27 construct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 A4 containing the pART27 plasmid, respectively. (C) Sterile culture. (D) Induction of ginseng hairy roots. (E) Proliferation of ginseng hairy roots; (F) Liquid culture of ginseng hairy root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4638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5</TotalTime>
  <Words>9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8</cp:revision>
  <dcterms:created xsi:type="dcterms:W3CDTF">2024-03-31T12:25:52Z</dcterms:created>
  <dcterms:modified xsi:type="dcterms:W3CDTF">2024-07-10T09:23:47Z</dcterms:modified>
</cp:coreProperties>
</file>